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57" r:id="rId2"/>
    <p:sldId id="258" r:id="rId3"/>
    <p:sldId id="259" r:id="rId4"/>
    <p:sldId id="264" r:id="rId5"/>
    <p:sldId id="265" r:id="rId6"/>
    <p:sldId id="266" r:id="rId7"/>
    <p:sldId id="260" r:id="rId8"/>
    <p:sldId id="261" r:id="rId9"/>
    <p:sldId id="267" r:id="rId10"/>
    <p:sldId id="262" r:id="rId11"/>
    <p:sldId id="263" r:id="rId12"/>
  </p:sldIdLst>
  <p:sldSz cx="12192000" cy="6858000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65"/>
  </p:normalViewPr>
  <p:slideViewPr>
    <p:cSldViewPr snapToGrid="0" snapToObjects="1">
      <p:cViewPr varScale="1">
        <p:scale>
          <a:sx n="82" d="100"/>
          <a:sy n="82" d="100"/>
        </p:scale>
        <p:origin x="614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A5DFF9-DA7C-2748-9239-992F56690FEA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570AEE-B768-294B-A1A4-F506FF1131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538476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39C8B3-C1E1-4081-BFF6-28A19E1523D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986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_tradnl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98199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656820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908873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6128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70163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57980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5918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62284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81714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765694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13734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8F0803-D771-184E-838B-EB3A99AFB13F}" type="datetimeFigureOut">
              <a:rPr lang="es-ES_tradnl" smtClean="0"/>
              <a:t>20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370DCA-E5B2-AA45-A063-B3730D2B9D65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604414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j.falcao.salles@rug.nl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5E98-4611-5A41-8D49-5998DB3000DA}" type="slidenum">
              <a:rPr lang="en-US" smtClean="0"/>
              <a:t>1</a:t>
            </a:fld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5A75AC2-AE38-42D0-9591-438019C55860}"/>
              </a:ext>
            </a:extLst>
          </p:cNvPr>
          <p:cNvSpPr/>
          <p:nvPr/>
        </p:nvSpPr>
        <p:spPr>
          <a:xfrm>
            <a:off x="807720" y="-295096"/>
            <a:ext cx="11064240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endParaRPr lang="en-US" sz="2800" b="1" dirty="0"/>
          </a:p>
          <a:p>
            <a:pPr algn="ctr"/>
            <a:endParaRPr lang="en-US" sz="2800" b="1" dirty="0"/>
          </a:p>
          <a:p>
            <a:pPr algn="ctr"/>
            <a:r>
              <a:rPr lang="en-US" sz="2800" b="1" dirty="0"/>
              <a:t>Supplementary Information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Journal: </a:t>
            </a:r>
            <a:r>
              <a:rPr lang="en-US" dirty="0"/>
              <a:t>Microbial Ecology</a:t>
            </a:r>
          </a:p>
          <a:p>
            <a:endParaRPr lang="en-US" b="1" dirty="0"/>
          </a:p>
          <a:p>
            <a:r>
              <a:rPr lang="en-US" b="1" dirty="0"/>
              <a:t>Manuscript tittle: </a:t>
            </a:r>
            <a:r>
              <a:rPr lang="en-US" dirty="0"/>
              <a:t> </a:t>
            </a:r>
            <a:r>
              <a:rPr lang="en-US" b="1" dirty="0"/>
              <a:t>DYNAMICS OF ABUNDANT AND RARE BACTERIA DURING DEGRADATION OF LIGNOCELLULOSE FROM SUGARCANE BIOMASS</a:t>
            </a:r>
            <a:endParaRPr lang="en-NL" dirty="0"/>
          </a:p>
          <a:p>
            <a:endParaRPr lang="en-US" dirty="0"/>
          </a:p>
          <a:p>
            <a:r>
              <a:rPr lang="en-US" b="1" dirty="0"/>
              <a:t>Authors: </a:t>
            </a:r>
            <a:r>
              <a:rPr lang="es-EC" dirty="0"/>
              <a:t>Pilar Eliana Puentes-Téllez</a:t>
            </a:r>
            <a:r>
              <a:rPr lang="es-EC" baseline="30000" dirty="0"/>
              <a:t>1,2 </a:t>
            </a:r>
            <a:r>
              <a:rPr lang="es-EC" dirty="0"/>
              <a:t>and Joana </a:t>
            </a:r>
            <a:r>
              <a:rPr lang="es-EC" dirty="0" err="1"/>
              <a:t>Falcao</a:t>
            </a:r>
            <a:r>
              <a:rPr lang="es-EC" dirty="0"/>
              <a:t> Salles</a:t>
            </a:r>
            <a:r>
              <a:rPr lang="es-EC" baseline="30000" dirty="0"/>
              <a:t>1</a:t>
            </a:r>
            <a:r>
              <a:rPr lang="es-EC" dirty="0"/>
              <a:t>*</a:t>
            </a:r>
            <a:endParaRPr lang="en-US" dirty="0"/>
          </a:p>
          <a:p>
            <a:r>
              <a:rPr lang="es-EC" dirty="0"/>
              <a:t> </a:t>
            </a:r>
            <a:endParaRPr lang="en-US" dirty="0"/>
          </a:p>
          <a:p>
            <a:endParaRPr lang="es-ES" dirty="0"/>
          </a:p>
          <a:p>
            <a:r>
              <a:rPr lang="en-US" b="1" dirty="0"/>
              <a:t>*Corresponding author:</a:t>
            </a:r>
            <a:r>
              <a:rPr lang="en-US" dirty="0"/>
              <a:t> </a:t>
            </a:r>
            <a:r>
              <a:rPr lang="en-US" u="sng" dirty="0">
                <a:hlinkClick r:id="rId2"/>
              </a:rPr>
              <a:t>j.falcao.salles@rug.nl</a:t>
            </a:r>
            <a:r>
              <a:rPr lang="en-US" dirty="0"/>
              <a:t>; Tel.: +31 50 363 2162</a:t>
            </a:r>
          </a:p>
          <a:p>
            <a:endParaRPr lang="es-ES" dirty="0"/>
          </a:p>
          <a:p>
            <a:endParaRPr lang="es-ES" dirty="0"/>
          </a:p>
          <a:p>
            <a:endParaRPr lang="en-US" dirty="0"/>
          </a:p>
          <a:p>
            <a:r>
              <a:rPr lang="en-US" baseline="30000" dirty="0"/>
              <a:t>1</a:t>
            </a:r>
            <a:r>
              <a:rPr lang="en-US" dirty="0"/>
              <a:t>Microbial Community Ecology, GELIFES — Groningen Institute for Evolutionary Life Sciences. University of Groningen, </a:t>
            </a:r>
            <a:r>
              <a:rPr lang="en-US" dirty="0" err="1"/>
              <a:t>Nijenborgh</a:t>
            </a:r>
            <a:r>
              <a:rPr lang="en-US" dirty="0"/>
              <a:t> 7, 9747 AG, Groningen, The Netherlands</a:t>
            </a:r>
          </a:p>
          <a:p>
            <a:r>
              <a:rPr lang="en-US" b="1" baseline="30000" dirty="0"/>
              <a:t>2</a:t>
            </a:r>
            <a:r>
              <a:rPr lang="en-US" b="1" dirty="0"/>
              <a:t> </a:t>
            </a:r>
            <a:r>
              <a:rPr lang="en-US" dirty="0"/>
              <a:t>Current address:</a:t>
            </a:r>
            <a:r>
              <a:rPr lang="en-US" b="1" dirty="0"/>
              <a:t> </a:t>
            </a:r>
            <a:r>
              <a:rPr lang="en-US" dirty="0"/>
              <a:t>Department of Biology, Institute of Environmental Biology, Ecology and Biodiversity Group, </a:t>
            </a:r>
            <a:r>
              <a:rPr lang="en-US" dirty="0" err="1"/>
              <a:t>Padualaan</a:t>
            </a:r>
            <a:r>
              <a:rPr lang="en-US" dirty="0"/>
              <a:t> 8, 3584 CH  Utrecht, The Netherlands</a:t>
            </a:r>
          </a:p>
        </p:txBody>
      </p:sp>
    </p:spTree>
    <p:extLst>
      <p:ext uri="{BB962C8B-B14F-4D97-AF65-F5344CB8AC3E}">
        <p14:creationId xmlns:p14="http://schemas.microsoft.com/office/powerpoint/2010/main" val="2597172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1200" dirty="0">
                <a:latin typeface="Cambria" panose="02040503050406030204" pitchFamily="18" charset="0"/>
                <a:cs typeface="Times New Roman"/>
              </a:rPr>
              <a:t>Table S3. R</a:t>
            </a:r>
            <a:r>
              <a:rPr lang="en-US" sz="1200" baseline="30000" dirty="0">
                <a:latin typeface="Cambria" panose="02040503050406030204" pitchFamily="18" charset="0"/>
                <a:cs typeface="Times New Roman"/>
              </a:rPr>
              <a:t>2</a:t>
            </a:r>
            <a:r>
              <a:rPr lang="en-US" sz="1200" dirty="0">
                <a:latin typeface="Cambria" panose="02040503050406030204" pitchFamily="18" charset="0"/>
                <a:cs typeface="Times New Roman"/>
              </a:rPr>
              <a:t> and significance values of  %D along the enrichment. </a:t>
            </a:r>
            <a:br>
              <a:rPr lang="en-US" sz="1200" dirty="0">
                <a:latin typeface="Cambria" panose="02040503050406030204" pitchFamily="18" charset="0"/>
                <a:cs typeface="Times New Roman"/>
              </a:rPr>
            </a:br>
            <a:r>
              <a:rPr lang="en-US" sz="1200" dirty="0">
                <a:latin typeface="Cambria" panose="02040503050406030204" pitchFamily="18" charset="0"/>
                <a:cs typeface="Times New Roman"/>
              </a:rPr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5E98-4611-5A41-8D49-5998DB3000DA}" type="slidenum">
              <a:rPr lang="en-US" smtClean="0"/>
              <a:t>10</a:t>
            </a:fld>
            <a:endParaRPr lang="en-US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7700" y="2882900"/>
            <a:ext cx="5816600" cy="107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457164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5E98-4611-5A41-8D49-5998DB3000DA}" type="slidenum">
              <a:rPr lang="en-US" smtClean="0"/>
              <a:t>11</a:t>
            </a:fld>
            <a:endParaRPr lang="en-US"/>
          </a:p>
        </p:txBody>
      </p:sp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944880" y="212725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en-US" sz="1200" dirty="0">
                <a:latin typeface="Cambria" panose="02040503050406030204" pitchFamily="18" charset="0"/>
                <a:cs typeface="Times New Roman"/>
              </a:rPr>
              <a:t>Table S4. R</a:t>
            </a:r>
            <a:r>
              <a:rPr lang="en-US" sz="1200" baseline="30000" dirty="0">
                <a:latin typeface="Cambria" panose="02040503050406030204" pitchFamily="18" charset="0"/>
                <a:cs typeface="Times New Roman"/>
              </a:rPr>
              <a:t>2 </a:t>
            </a:r>
            <a:r>
              <a:rPr lang="en-US" sz="1200" dirty="0">
                <a:latin typeface="Cambria" panose="02040503050406030204" pitchFamily="18" charset="0"/>
                <a:cs typeface="Times New Roman"/>
              </a:rPr>
              <a:t> and </a:t>
            </a:r>
            <a:r>
              <a:rPr lang="en-US" sz="1200" i="1" dirty="0">
                <a:latin typeface="Cambria" panose="02040503050406030204" pitchFamily="18" charset="0"/>
                <a:cs typeface="Times New Roman"/>
              </a:rPr>
              <a:t>P</a:t>
            </a:r>
            <a:r>
              <a:rPr lang="en-US" sz="1200" dirty="0">
                <a:latin typeface="Cambria" panose="02040503050406030204" pitchFamily="18" charset="0"/>
                <a:cs typeface="Times New Roman"/>
              </a:rPr>
              <a:t> values of the correlation between α-diversity measurements and the degradation of the three </a:t>
            </a:r>
            <a:r>
              <a:rPr lang="en-US" sz="1200" dirty="0" err="1">
                <a:latin typeface="Cambria" panose="02040503050406030204" pitchFamily="18" charset="0"/>
                <a:cs typeface="Times New Roman"/>
              </a:rPr>
              <a:t>lignocellulosic</a:t>
            </a:r>
            <a:r>
              <a:rPr lang="en-US" sz="1200" dirty="0">
                <a:latin typeface="Cambria" panose="02040503050406030204" pitchFamily="18" charset="0"/>
                <a:cs typeface="Times New Roman"/>
              </a:rPr>
              <a:t> fractions 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0900" y="2222500"/>
            <a:ext cx="5397500" cy="2400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8511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81201" y="824157"/>
            <a:ext cx="7139037" cy="452596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300" b="1" dirty="0">
                <a:latin typeface="Cambria" panose="02040503050406030204" pitchFamily="18" charset="0"/>
                <a:cs typeface="Times"/>
              </a:rPr>
              <a:t>PCR amplification and DGGE analysis</a:t>
            </a:r>
          </a:p>
          <a:p>
            <a:endParaRPr lang="en-US" sz="1300" dirty="0">
              <a:latin typeface="Cambria" panose="02040503050406030204" pitchFamily="18" charset="0"/>
              <a:cs typeface="Times"/>
            </a:endParaRPr>
          </a:p>
          <a:p>
            <a:pPr marL="0" indent="0" algn="just">
              <a:buNone/>
            </a:pPr>
            <a:r>
              <a:rPr lang="en-US" sz="1300" dirty="0">
                <a:latin typeface="Cambria" panose="02040503050406030204" pitchFamily="18" charset="0"/>
                <a:cs typeface="Times"/>
              </a:rPr>
              <a:t>6ng/µL of DNA were used as template for a PCR using the primers F968 with a GC clamp attached to the 5’ end and the universal bacterial primer R1401 (1b) for 16S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rRNA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gene. PCR reagents and conditions were described by Pereira e Silva et al. (2012). Denaturing gradient gel electrophoresis (DGGE) was performed in the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Ingeny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Phor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-U System (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Ingeny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International, Goes, The Netherlands) using 6 % (w/v) polyacrylamide gels with 45–65 denaturant gradient for bacterial communities.  Electrophoresis was carried out at 100 V for 16 h at 60 °C and the gels were stained for 30 min in 0.5 % TAE buffer with SYBR gold (final concentration of 0.5 μg/l) (Invitrogen, Breda, The Netherlands). Images were taken using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Imagemaster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VDS (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Amersham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Biosciences, Buckinghamshire, UK). Fingerprinting results were analyzed using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GelCompar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software (Applied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Maths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,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Sint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Martens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Latem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, Belgium) and then principal components analysis (PCA) was performed to the DGGE banding pattern using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Canoco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v5.0  (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ter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Braak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CJF, </a:t>
            </a:r>
            <a:r>
              <a:rPr lang="en-US" sz="1300" dirty="0" err="1">
                <a:latin typeface="Cambria" panose="02040503050406030204" pitchFamily="18" charset="0"/>
                <a:cs typeface="Times"/>
              </a:rPr>
              <a:t>Šmilauer</a:t>
            </a:r>
            <a:r>
              <a:rPr lang="en-US" sz="1300" dirty="0">
                <a:latin typeface="Cambria" panose="02040503050406030204" pitchFamily="18" charset="0"/>
                <a:cs typeface="Times"/>
              </a:rPr>
              <a:t> P , 2012).  </a:t>
            </a:r>
          </a:p>
          <a:p>
            <a:endParaRPr lang="en-US" sz="1300" dirty="0">
              <a:latin typeface="Cambria" panose="02040503050406030204" pitchFamily="18" charset="0"/>
              <a:cs typeface="Time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5E98-4611-5A41-8D49-5998DB3000D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3441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7569144" y="1330739"/>
            <a:ext cx="5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>
                <a:latin typeface="Times"/>
                <a:cs typeface="Times"/>
              </a:rPr>
              <a:t>S15</a:t>
            </a:r>
            <a:endParaRPr lang="en-US" dirty="0">
              <a:latin typeface="Times"/>
              <a:cs typeface="Times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520908" y="18574"/>
            <a:ext cx="1003100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Cambria" panose="02040503050406030204" pitchFamily="18" charset="0"/>
                <a:cs typeface="Times New Roman"/>
              </a:rPr>
              <a:t>Fig S1. </a:t>
            </a:r>
            <a:r>
              <a:rPr lang="en-US" sz="1200" b="1" dirty="0">
                <a:latin typeface="Cambria" panose="02040503050406030204" pitchFamily="18" charset="0"/>
                <a:cs typeface="Times New Roman"/>
              </a:rPr>
              <a:t>Stabilization of the communities and drivers of selection analyzed by DGGE fingerprinting</a:t>
            </a:r>
            <a:endParaRPr lang="en-US" sz="1200" dirty="0">
              <a:latin typeface="Cambria" panose="02040503050406030204" pitchFamily="18" charset="0"/>
              <a:cs typeface="Times New Roman"/>
            </a:endParaRPr>
          </a:p>
          <a:p>
            <a:pPr algn="just"/>
            <a:r>
              <a:rPr lang="en-US" sz="1200" dirty="0">
                <a:latin typeface="Cambria" panose="02040503050406030204" pitchFamily="18" charset="0"/>
                <a:cs typeface="Times New Roman"/>
              </a:rPr>
              <a:t>Analysis of gels revealed the structure and stability of the communities along the enrichment. A PCA analysis performed on the band patterns including the samples from the beginning of the enrichment (First half of the experiment: T1, T2, T3), a more advanced stage of the enrichment (Second half of the experiment: T6, T8, T10) and each inoculum. Results reveal a quick stabilization (from T3) in all the communities . S0 communities (coming from straw-untreated soil) however, show a slower transition towards stabilization.  Δ  soil </a:t>
            </a:r>
            <a:r>
              <a:rPr lang="en-US" sz="1200" dirty="0" err="1">
                <a:latin typeface="Cambria" panose="02040503050406030204" pitchFamily="18" charset="0"/>
                <a:cs typeface="Times New Roman"/>
              </a:rPr>
              <a:t>inocula</a:t>
            </a:r>
            <a:r>
              <a:rPr lang="en-US" sz="1200" dirty="0">
                <a:latin typeface="Cambria" panose="02040503050406030204" pitchFamily="18" charset="0"/>
                <a:cs typeface="Times New Roman"/>
              </a:rPr>
              <a:t> (S0, S15). T: Transfer, r: consecutive replicates . Arrows indicate time and trajectory.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054048" y="1376491"/>
            <a:ext cx="4284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>
                <a:latin typeface="Times"/>
                <a:cs typeface="Times"/>
              </a:rPr>
              <a:t>S0</a:t>
            </a:r>
            <a:endParaRPr lang="en-US" dirty="0">
              <a:latin typeface="Times"/>
              <a:cs typeface="Times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 flipV="1">
            <a:off x="2610822" y="1717512"/>
            <a:ext cx="3237306" cy="1352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 flipV="1">
            <a:off x="6234990" y="1715279"/>
            <a:ext cx="3237306" cy="1352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 flipV="1">
            <a:off x="2445781" y="2197119"/>
            <a:ext cx="0" cy="1496295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flipV="1">
            <a:off x="2466327" y="4924089"/>
            <a:ext cx="0" cy="1496295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 rot="16200000">
            <a:off x="1793399" y="2789932"/>
            <a:ext cx="935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"/>
                <a:cs typeface="Times"/>
              </a:rPr>
              <a:t>Bagasse</a:t>
            </a:r>
          </a:p>
        </p:txBody>
      </p:sp>
      <p:sp>
        <p:nvSpPr>
          <p:cNvPr id="67" name="TextBox 66"/>
          <p:cNvSpPr txBox="1"/>
          <p:nvPr/>
        </p:nvSpPr>
        <p:spPr>
          <a:xfrm rot="16200000">
            <a:off x="1919612" y="5537217"/>
            <a:ext cx="724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"/>
                <a:cs typeface="Times"/>
              </a:rPr>
              <a:t>Straw</a:t>
            </a:r>
          </a:p>
        </p:txBody>
      </p:sp>
      <p:pic>
        <p:nvPicPr>
          <p:cNvPr id="71" name="Picture 70" descr="BAGASSE_2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1120" y="1612387"/>
            <a:ext cx="4131951" cy="3034225"/>
          </a:xfrm>
          <a:prstGeom prst="rect">
            <a:avLst/>
          </a:prstGeom>
        </p:spPr>
      </p:pic>
      <p:pic>
        <p:nvPicPr>
          <p:cNvPr id="72" name="Picture 71" descr="BAGASES1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4233" y="1700072"/>
            <a:ext cx="3474640" cy="2551541"/>
          </a:xfrm>
          <a:prstGeom prst="rect">
            <a:avLst/>
          </a:prstGeom>
        </p:spPr>
      </p:pic>
      <p:pic>
        <p:nvPicPr>
          <p:cNvPr id="73" name="Picture 72" descr="STRAW_1.pd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6924" y="4161503"/>
            <a:ext cx="4822221" cy="2877431"/>
          </a:xfrm>
          <a:prstGeom prst="rect">
            <a:avLst/>
          </a:prstGeom>
        </p:spPr>
      </p:pic>
      <p:pic>
        <p:nvPicPr>
          <p:cNvPr id="74" name="Picture 73" descr="STRAW-2.pd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3853" y="4425284"/>
            <a:ext cx="2866187" cy="25763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3241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7BD3669-B3E9-4262-905D-4C89C2D8296D}"/>
              </a:ext>
            </a:extLst>
          </p:cNvPr>
          <p:cNvSpPr txBox="1"/>
          <p:nvPr/>
        </p:nvSpPr>
        <p:spPr>
          <a:xfrm>
            <a:off x="409633" y="761962"/>
            <a:ext cx="10031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Cambria" panose="02040503050406030204" pitchFamily="18" charset="0"/>
                <a:cs typeface="Times New Roman"/>
              </a:rPr>
              <a:t>Fig S2.  </a:t>
            </a:r>
            <a:r>
              <a:rPr lang="en-US" sz="1200" dirty="0" err="1">
                <a:latin typeface="Cambria" panose="02040503050406030204" pitchFamily="18" charset="0"/>
                <a:cs typeface="Times New Roman"/>
              </a:rPr>
              <a:t>Rarefraction</a:t>
            </a:r>
            <a:r>
              <a:rPr lang="en-US" sz="1200" dirty="0">
                <a:latin typeface="Cambria" panose="02040503050406030204" pitchFamily="18" charset="0"/>
                <a:cs typeface="Times New Roman"/>
              </a:rPr>
              <a:t> curves and abundance-taxa plots (at family level) obtain across all samples using QIIME toolkit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FC254A4-4E9A-4E00-9E74-E5CA5EE81E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78" y="1325166"/>
            <a:ext cx="5210246" cy="390768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87D0EF4-2DB2-409F-95B3-CBBB9344E5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95264" y="1767696"/>
            <a:ext cx="2362405" cy="332260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1536E77-FC06-4A40-9498-9E56A2B5D8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38733" y="1817230"/>
            <a:ext cx="2232853" cy="322353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1785372-608B-457C-A040-268FD2F77F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91411" y="4917317"/>
            <a:ext cx="2209992" cy="990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01679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0EB3F52-3E96-4B55-A8DA-F9F2C41D1E22}"/>
              </a:ext>
            </a:extLst>
          </p:cNvPr>
          <p:cNvGrpSpPr/>
          <p:nvPr/>
        </p:nvGrpSpPr>
        <p:grpSpPr>
          <a:xfrm>
            <a:off x="1607127" y="332509"/>
            <a:ext cx="8303335" cy="6131964"/>
            <a:chOff x="1607127" y="332509"/>
            <a:chExt cx="8303335" cy="6131964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01D9953-F9E6-4CD9-87F2-6CDD00DA7F35}"/>
                </a:ext>
              </a:extLst>
            </p:cNvPr>
            <p:cNvSpPr txBox="1"/>
            <p:nvPr/>
          </p:nvSpPr>
          <p:spPr>
            <a:xfrm>
              <a:off x="1607127" y="332509"/>
              <a:ext cx="32881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Cambria" panose="02040503050406030204" pitchFamily="18" charset="0"/>
                  <a:ea typeface="Cambria" panose="02040503050406030204" pitchFamily="18" charset="0"/>
                </a:rPr>
                <a:t>Abundance taxa plots</a:t>
              </a:r>
              <a:endParaRPr lang="en-NL" sz="1600" dirty="0"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CBBCD990-8375-438C-86EA-C3DD6903324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07127" y="671063"/>
              <a:ext cx="8151842" cy="5684397"/>
            </a:xfrm>
            <a:prstGeom prst="rect">
              <a:avLst/>
            </a:prstGeom>
          </p:spPr>
        </p:pic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F3EEFFDF-C80E-4CB4-ABFB-77D7FC37EDC9}"/>
                </a:ext>
              </a:extLst>
            </p:cNvPr>
            <p:cNvSpPr/>
            <p:nvPr/>
          </p:nvSpPr>
          <p:spPr>
            <a:xfrm rot="16200000">
              <a:off x="5534535" y="2088546"/>
              <a:ext cx="449581" cy="830227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Bag1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Bag2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Bag3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S1a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S1c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S2a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S2c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Str2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1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2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3</a:t>
              </a:r>
              <a:r>
                <a:rPr lang="es-HN" sz="550" dirty="0"/>
                <a:t> 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5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6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7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8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9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1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2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3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5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6</a:t>
              </a:r>
              <a:r>
                <a:rPr lang="es-HN" sz="550" dirty="0"/>
                <a:t> </a:t>
              </a:r>
              <a:endParaRPr lang="es-HN" sz="550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7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8</a:t>
              </a:r>
              <a:r>
                <a:rPr lang="es-HN" sz="550" dirty="0"/>
                <a:t> 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9</a:t>
              </a:r>
              <a:r>
                <a:rPr lang="es-HN" sz="550" dirty="0"/>
                <a:t> 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1</a:t>
              </a:r>
              <a:r>
                <a:rPr lang="es-HN" sz="550" dirty="0"/>
                <a:t> 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2</a:t>
              </a:r>
              <a:r>
                <a:rPr lang="es-HN" sz="550" dirty="0"/>
                <a:t> 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3</a:t>
              </a:r>
              <a:r>
                <a:rPr lang="es-HN" sz="550" dirty="0"/>
                <a:t> 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5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6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7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8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9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1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2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3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5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6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7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8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9</a:t>
              </a:r>
            </a:p>
            <a:p>
              <a:pPr>
                <a:lnSpc>
                  <a:spcPct val="150000"/>
                </a:lnSpc>
              </a:pPr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2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3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5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6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7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8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9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10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11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12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13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1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15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16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-18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10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11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12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13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1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15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16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2-18</a:t>
              </a:r>
            </a:p>
            <a:p>
              <a:pPr>
                <a:lnSpc>
                  <a:spcPct val="150000"/>
                </a:lnSpc>
              </a:pPr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10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11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12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13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1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15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16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3-18</a:t>
              </a:r>
              <a:r>
                <a:rPr lang="es-HN" sz="550" dirty="0"/>
                <a:t> 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10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11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12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13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1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15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16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6-17</a:t>
              </a:r>
              <a:r>
                <a:rPr lang="es-HN" sz="550" dirty="0"/>
                <a:t> 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0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1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2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3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4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5</a:t>
              </a:r>
              <a:r>
                <a:rPr lang="es-HN" sz="550" dirty="0"/>
                <a:t> </a:t>
              </a:r>
            </a:p>
            <a:p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6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7</a:t>
              </a:r>
            </a:p>
            <a:p>
              <a:r>
                <a:rPr lang="es-HN" sz="550" dirty="0"/>
                <a:t> </a:t>
              </a:r>
              <a:r>
                <a:rPr lang="es-HN" sz="550" dirty="0">
                  <a:solidFill>
                    <a:srgbClr val="000000"/>
                  </a:solidFill>
                  <a:latin typeface="Calibri" panose="020F0502020204030204" pitchFamily="34" charset="0"/>
                </a:rPr>
                <a:t>T10-18</a:t>
              </a:r>
              <a:r>
                <a:rPr lang="es-HN" sz="550" dirty="0"/>
                <a:t> </a:t>
              </a:r>
              <a:endParaRPr lang="en-NL" sz="550" dirty="0"/>
            </a:p>
          </p:txBody>
        </p:sp>
      </p:grpSp>
    </p:spTree>
    <p:extLst>
      <p:ext uri="{BB962C8B-B14F-4D97-AF65-F5344CB8AC3E}">
        <p14:creationId xmlns:p14="http://schemas.microsoft.com/office/powerpoint/2010/main" val="39679175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4BE1215-44F5-47CF-975C-67A4990518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292"/>
            <a:ext cx="4029900" cy="517031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BBDDB50-3A09-4B9F-BE29-CC74D349AE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11681" y="396127"/>
            <a:ext cx="3879316" cy="510080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1442827-FDE9-41CA-B2B0-5847AA6DE6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90997" y="396127"/>
            <a:ext cx="4029900" cy="533481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95C1727-6312-4616-8591-47E097F237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90997" y="5730946"/>
            <a:ext cx="4029900" cy="93821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36E6EF9-E265-46E5-B67B-B7C90426912A}"/>
              </a:ext>
            </a:extLst>
          </p:cNvPr>
          <p:cNvSpPr txBox="1"/>
          <p:nvPr/>
        </p:nvSpPr>
        <p:spPr>
          <a:xfrm flipH="1">
            <a:off x="0" y="-32266"/>
            <a:ext cx="1269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lor code</a:t>
            </a:r>
            <a:endParaRPr lang="en-NL" dirty="0"/>
          </a:p>
        </p:txBody>
      </p:sp>
    </p:spTree>
    <p:extLst>
      <p:ext uri="{BB962C8B-B14F-4D97-AF65-F5344CB8AC3E}">
        <p14:creationId xmlns:p14="http://schemas.microsoft.com/office/powerpoint/2010/main" val="20484064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7794820" y="6693384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.6%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652644" y="134079"/>
            <a:ext cx="818488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mbria" panose="02040503050406030204" pitchFamily="18" charset="0"/>
                <a:cs typeface="Times"/>
              </a:rPr>
              <a:t>Fig S3. Redundancy analysis (RDA) depicting the linear relationship between a) abundant and b) rare family taxonomic groups and the environmental variables (</a:t>
            </a:r>
            <a:r>
              <a:rPr lang="en-US" sz="1200" dirty="0" err="1">
                <a:latin typeface="Cambria" panose="02040503050406030204" pitchFamily="18" charset="0"/>
                <a:cs typeface="Times"/>
              </a:rPr>
              <a:t>Lignocellulosic</a:t>
            </a:r>
            <a:r>
              <a:rPr lang="en-US" sz="1200" dirty="0">
                <a:latin typeface="Cambria" panose="02040503050406030204" pitchFamily="18" charset="0"/>
                <a:cs typeface="Times"/>
              </a:rPr>
              <a:t> components) across all samples (T6 and T10). Red Arrows indicate correlation between the lignocellulose components  and sample community structure</a:t>
            </a:r>
          </a:p>
          <a:p>
            <a:endParaRPr lang="en-US" sz="1200" dirty="0">
              <a:latin typeface="Cambria" panose="02040503050406030204" pitchFamily="18" charset="0"/>
              <a:cs typeface="Times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652644" y="1057409"/>
            <a:ext cx="9184390" cy="4391311"/>
            <a:chOff x="128644" y="1057408"/>
            <a:chExt cx="9184390" cy="4391311"/>
          </a:xfrm>
        </p:grpSpPr>
        <p:pic>
          <p:nvPicPr>
            <p:cNvPr id="2" name="Picture 1" descr="t6yt10abu.pd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644" y="1057408"/>
              <a:ext cx="5844164" cy="4391311"/>
            </a:xfrm>
            <a:prstGeom prst="rect">
              <a:avLst/>
            </a:prstGeom>
          </p:spPr>
        </p:pic>
        <p:pic>
          <p:nvPicPr>
            <p:cNvPr id="4" name="Picture 3" descr="Raret6ty10.pd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71165" y="1057408"/>
              <a:ext cx="5241869" cy="4391311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28644" y="1057408"/>
              <a:ext cx="13776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Times"/>
                  <a:cs typeface="Times"/>
                </a:rPr>
                <a:t>a) Abundant 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206771" y="1079633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Times"/>
                  <a:cs typeface="Times"/>
                </a:rPr>
                <a:t>b) Rare </a:t>
              </a: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393847" y="1583186"/>
              <a:ext cx="500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10BS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802612" y="2395692"/>
              <a:ext cx="500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6BS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550960" y="3191486"/>
              <a:ext cx="500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6StS0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721560" y="3619626"/>
              <a:ext cx="60622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10StS0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661033" y="4003086"/>
              <a:ext cx="61691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10StS15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669388" y="3660500"/>
              <a:ext cx="61691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10BS15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179935" y="3165999"/>
              <a:ext cx="5076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6BS15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100995" y="3301687"/>
              <a:ext cx="58106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6StS15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246597" y="3079274"/>
              <a:ext cx="500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6BS0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694745" y="3793290"/>
              <a:ext cx="500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6StS0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230775" y="3670013"/>
              <a:ext cx="5076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6BS15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692589" y="3986144"/>
              <a:ext cx="61691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10BS15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754320" y="3637495"/>
              <a:ext cx="58106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6StS15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641362" y="3048035"/>
              <a:ext cx="60622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10StS0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348185" y="4573276"/>
              <a:ext cx="61691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10StS15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964755" y="1645482"/>
              <a:ext cx="500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T10BS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902645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1600" dirty="0">
                <a:latin typeface="Cambria" panose="02040503050406030204" pitchFamily="18" charset="0"/>
                <a:cs typeface="Times"/>
              </a:rPr>
              <a:t>Table S1. Pure cellulose, hemicelluloses and lignin mixtures used to obtain reference spectra.</a:t>
            </a:r>
            <a:br>
              <a:rPr lang="en-US" sz="1600" dirty="0">
                <a:latin typeface="Cambria" panose="02040503050406030204" pitchFamily="18" charset="0"/>
                <a:cs typeface="Times"/>
              </a:rPr>
            </a:br>
            <a:endParaRPr lang="en-US" sz="1600" dirty="0">
              <a:latin typeface="Cambria" panose="02040503050406030204" pitchFamily="18" charset="0"/>
              <a:cs typeface="Time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5E98-4611-5A41-8D49-5998DB3000DA}" type="slidenum">
              <a:rPr lang="en-US" smtClean="0"/>
              <a:t>8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6049" y="1644810"/>
            <a:ext cx="5905500" cy="52959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839510" y="6590670"/>
            <a:ext cx="12218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>
                <a:latin typeface="Times"/>
                <a:cs typeface="Times"/>
              </a:rPr>
              <a:t>Adapa</a:t>
            </a:r>
            <a:r>
              <a:rPr lang="en-US" sz="1100" dirty="0">
                <a:latin typeface="Times"/>
                <a:cs typeface="Times"/>
              </a:rPr>
              <a:t> </a:t>
            </a:r>
            <a:r>
              <a:rPr lang="en-US" sz="1100" i="1" dirty="0">
                <a:latin typeface="Times"/>
                <a:cs typeface="Times"/>
              </a:rPr>
              <a:t>et al.</a:t>
            </a:r>
            <a:r>
              <a:rPr lang="en-US" sz="1100" dirty="0">
                <a:latin typeface="Times"/>
                <a:cs typeface="Times"/>
              </a:rPr>
              <a:t>, 2011</a:t>
            </a:r>
          </a:p>
        </p:txBody>
      </p:sp>
    </p:spTree>
    <p:extLst>
      <p:ext uri="{BB962C8B-B14F-4D97-AF65-F5344CB8AC3E}">
        <p14:creationId xmlns:p14="http://schemas.microsoft.com/office/powerpoint/2010/main" val="11576727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759CA23-45C0-449B-A3AC-8458DADAC8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093" y="1968750"/>
            <a:ext cx="11603814" cy="2920500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E97F0BA3-6DA6-445C-8E5C-E1A43F3ED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>
            <a:noAutofit/>
          </a:bodyPr>
          <a:lstStyle/>
          <a:p>
            <a:r>
              <a:rPr lang="en-US" sz="1600" dirty="0">
                <a:latin typeface="Cambria" panose="02040503050406030204" pitchFamily="18" charset="0"/>
                <a:cs typeface="Times"/>
              </a:rPr>
              <a:t>Table S2. Relative abundance values of the “top” abundant and “top” rare taxa. All abundant taxa have a value of &gt;2% at least once during the enrichment . All rare taxa have </a:t>
            </a:r>
            <a:r>
              <a:rPr lang="en-US" sz="1600">
                <a:latin typeface="Cambria" panose="02040503050406030204" pitchFamily="18" charset="0"/>
                <a:cs typeface="Times"/>
              </a:rPr>
              <a:t>a value of &lt;1% . </a:t>
            </a:r>
            <a:endParaRPr lang="en-US" sz="1600" dirty="0">
              <a:latin typeface="Cambria" panose="02040503050406030204" pitchFamily="18" charset="0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20860014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287</TotalTime>
  <Words>713</Words>
  <Application>Microsoft Office PowerPoint</Application>
  <PresentationFormat>Widescreen</PresentationFormat>
  <Paragraphs>157</Paragraphs>
  <Slides>1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libri Light</vt:lpstr>
      <vt:lpstr>Cambria</vt:lpstr>
      <vt:lpstr>Times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able S1. Pure cellulose, hemicelluloses and lignin mixtures used to obtain reference spectra. </vt:lpstr>
      <vt:lpstr>Table S2. Relative abundance values of the “top” abundant and “top” rare taxa. All abundant taxa have a value of &gt;2% at least once during the enrichment . All rare taxa have a value of &lt;1% . </vt:lpstr>
      <vt:lpstr>Table S3. R2 and significance values of  %D along the enrichment.   </vt:lpstr>
      <vt:lpstr>Table S4. R2  and P values of the correlation between α-diversity measurements and the degradation of the three lignocellulosic fractions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Information</dc:title>
  <dc:creator>María Alejandra Puentes Téllez</dc:creator>
  <cp:lastModifiedBy>Pilar E. Puentes</cp:lastModifiedBy>
  <cp:revision>16</cp:revision>
  <dcterms:created xsi:type="dcterms:W3CDTF">2018-01-15T17:06:44Z</dcterms:created>
  <dcterms:modified xsi:type="dcterms:W3CDTF">2019-02-20T09:32:39Z</dcterms:modified>
</cp:coreProperties>
</file>